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62801-6D00-4DA1-821C-1BD60DD2FC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0DBBC1-17AC-41CB-8D3B-DDC91AB7B0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23DBE3-0A29-42A0-8AEA-5A28DC2CB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41730F-F299-471A-A621-650477204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548B7E-1EB1-4A32-94E5-B3A338A34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449283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72869-3588-4A84-ACA2-498570CCA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961370-DDCC-41EA-9817-47CE1CA588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65BD8-4FE8-449A-B592-6F53DA6B6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2A5937-56AF-41B5-AFCF-0AA9C2B2C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D78EE0-FC98-4A90-95CC-D91C1C5BB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932624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29A47D-75FC-4E04-B950-B89ADDBA4D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B443F-8CCF-4264-81A1-DE07066A0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E86B7-FAC1-4913-96BB-CE57C87B9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6FDC98-555C-4C10-AC69-1F6C769D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73DFAD-9538-47E1-85F4-A2DD48C4F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748479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28E1F2-E9F3-4C0D-B0F2-A5460F385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1C9A1-0673-4B47-A3BB-909052353C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4E4FDA-35C9-474D-B6B0-720B8BFCA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D3045F-FC08-4D75-AE38-E5BD855A9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A953A-D62F-45D7-A57D-3419468B5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153669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BBBCB8-CA03-4B1F-8A12-ABD546B11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F6264C-B8CD-4731-923A-F0678A3A5A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69A9D-1879-437B-BA86-4847C918F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79AEE-B881-46C4-B2AC-56BEC0AA7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C81DF-274A-47B3-AE83-65BEBB122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710701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A9820E-8901-460F-AC0B-A55799254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41029-3DE4-49EA-83F8-0A35FE7F2E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110B52-875B-4AB4-99CB-2533129490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F6E0E3-B21C-4878-92BB-D87C6B582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A69309-A9E4-4725-855B-34C9649A6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38BE00-7520-43F4-86EE-E03E83026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55755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7EC78-441A-478C-A9E8-E3647D6A3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B62A54-3CC1-4CE6-992D-5A8216A52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B295E7-E16C-4525-BD1F-F78AAA706A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7F2EFD-AC40-4F06-9CE9-623F12F428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D7BDAB-CEC8-4D52-B41C-A28B86F5F8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D2B7C0-BE1A-4B4B-82B3-75F3D520D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6F89BE-DD64-4317-BCC0-D7234CC6F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40214F-2013-44D3-BFCE-198D97F58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288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593651-2271-486D-956B-7F763B915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508F19-2684-4ED1-AC61-9727C7402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926DC9-A6C5-4190-9217-02A076F91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8FF08E-47AF-4E70-A911-E02230F3C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293595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1FB815-A92C-418C-91B5-D12E14D9E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A9D5BE-66E7-4D1B-9B09-6F3DFE74A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DEC0AE-D9D2-4D80-AF74-E069E9B09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71366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D2EC6-AE7F-4C5E-B053-83BB584DC9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F53024-EA16-47E6-AB9B-8982CCDA78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636B-3A6A-435E-8EDB-686FA8F8F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541C58-7C46-4C33-9945-A032B2D21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738ED4-602F-4D83-9A0A-A1ADFBC46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D6CE5E-1D6A-4AF1-AAC9-A307375CD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736787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ED058-65D6-4004-B6AD-08F6D8950E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674CFF-6984-4040-9480-DF0FA47FB6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1A60E2-021C-4D21-8794-31E0E212AF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2D3853-2766-4833-8FEE-6C4E4EDAF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E304CE-FEDC-44EB-A20A-379FC5EF2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41FD77-C101-4F40-884F-8608BA9A4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25531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57434E-D3F2-4B1E-97AD-3C62C8AF8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B966A9-B0AF-4579-9D6B-78E308F97B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9D6E2-56AD-43DE-B05F-8F7C666A3D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6A670-F418-4F54-88E1-4787244EEB02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1CB58F-F9CE-4A32-BA77-8ADBBFFC6E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74FA66-F3A9-4A22-BE0B-D3926CC2CC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1CE15F-4F16-4180-AFEF-00DE4BCB566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42245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C0595C-B83B-4BED-B55A-00A3243717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249" y="492890"/>
            <a:ext cx="7583647" cy="57868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AF74A60-7113-B16F-0827-DCCF2B0D1F02}"/>
              </a:ext>
            </a:extLst>
          </p:cNvPr>
          <p:cNvSpPr txBox="1"/>
          <p:nvPr/>
        </p:nvSpPr>
        <p:spPr>
          <a:xfrm>
            <a:off x="4085438" y="1661020"/>
            <a:ext cx="55199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5a. Reference range of WBC, RBC, HGB, HCT, MCV, MCH for healthy babies aged 2 months</a:t>
            </a:r>
          </a:p>
        </p:txBody>
      </p:sp>
    </p:spTree>
    <p:extLst>
      <p:ext uri="{BB962C8B-B14F-4D97-AF65-F5344CB8AC3E}">
        <p14:creationId xmlns:p14="http://schemas.microsoft.com/office/powerpoint/2010/main" val="1176236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5A580B4-A9C2-4E4D-8695-3B67A1A8E0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2164" y="864066"/>
            <a:ext cx="8769317" cy="49830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76EF871-A3CE-FD3F-25DE-4802D5251C83}"/>
              </a:ext>
            </a:extLst>
          </p:cNvPr>
          <p:cNvSpPr txBox="1"/>
          <p:nvPr/>
        </p:nvSpPr>
        <p:spPr>
          <a:xfrm>
            <a:off x="3238150" y="1853967"/>
            <a:ext cx="62917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5b. Reference range of MCHC, PLT, RDW SD, RDW CV, PDW, MPV, PCT, neutrophil for healthy babies aged 2 months</a:t>
            </a:r>
          </a:p>
        </p:txBody>
      </p:sp>
    </p:spTree>
    <p:extLst>
      <p:ext uri="{BB962C8B-B14F-4D97-AF65-F5344CB8AC3E}">
        <p14:creationId xmlns:p14="http://schemas.microsoft.com/office/powerpoint/2010/main" val="7947682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A3FC4C9-ED2B-4C4B-A661-2E254B4C80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8282" y="879835"/>
            <a:ext cx="8935436" cy="50983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B8E31EE-68E1-CC7F-253C-C39B478068B2}"/>
              </a:ext>
            </a:extLst>
          </p:cNvPr>
          <p:cNvSpPr txBox="1"/>
          <p:nvPr/>
        </p:nvSpPr>
        <p:spPr>
          <a:xfrm>
            <a:off x="2961313" y="1770077"/>
            <a:ext cx="7667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5c. Reference range of neutrophil, lymphocyte, monocyte, eosinophil, eosinophil </a:t>
            </a:r>
            <a:r>
              <a:rPr lang="en-ID" dirty="0" err="1"/>
              <a:t>absolut</a:t>
            </a:r>
            <a:r>
              <a:rPr lang="en-ID" dirty="0"/>
              <a:t>, basophil, basophil </a:t>
            </a:r>
            <a:r>
              <a:rPr lang="en-ID" dirty="0" err="1"/>
              <a:t>absolut</a:t>
            </a:r>
            <a:r>
              <a:rPr lang="en-ID" dirty="0"/>
              <a:t> for healthy babies aged 2 months</a:t>
            </a:r>
          </a:p>
        </p:txBody>
      </p:sp>
    </p:spTree>
    <p:extLst>
      <p:ext uri="{BB962C8B-B14F-4D97-AF65-F5344CB8AC3E}">
        <p14:creationId xmlns:p14="http://schemas.microsoft.com/office/powerpoint/2010/main" val="2785887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2D6A17D-C780-459F-9693-5740844C20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1413" y="851133"/>
            <a:ext cx="8423106" cy="526444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E73FE3D-6E58-958E-6524-44805CA6F652}"/>
              </a:ext>
            </a:extLst>
          </p:cNvPr>
          <p:cNvSpPr txBox="1"/>
          <p:nvPr/>
        </p:nvSpPr>
        <p:spPr>
          <a:xfrm>
            <a:off x="3615654" y="1669409"/>
            <a:ext cx="63085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5d. Reference range of IPF, IG,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, IRF, RPI for healthy babies aged 2 months</a:t>
            </a:r>
          </a:p>
        </p:txBody>
      </p:sp>
    </p:spTree>
    <p:extLst>
      <p:ext uri="{BB962C8B-B14F-4D97-AF65-F5344CB8AC3E}">
        <p14:creationId xmlns:p14="http://schemas.microsoft.com/office/powerpoint/2010/main" val="1300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09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2</cp:revision>
  <dcterms:created xsi:type="dcterms:W3CDTF">2022-02-16T21:52:04Z</dcterms:created>
  <dcterms:modified xsi:type="dcterms:W3CDTF">2022-07-23T22:45:25Z</dcterms:modified>
</cp:coreProperties>
</file>